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0416004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879912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809875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648656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072020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942704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651467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638093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432650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167796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3870987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9A9CD-DE84-4EEE-ABAB-E9C50D14D227}" type="datetimeFigureOut">
              <a:rPr lang="en-PH" smtClean="0"/>
              <a:t>24/01/2020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87CA5-29BC-48A9-86AE-C053E02178A2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122303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2"/>
          <p:cNvSpPr/>
          <p:nvPr/>
        </p:nvSpPr>
        <p:spPr>
          <a:xfrm>
            <a:off x="467544" y="400460"/>
            <a:ext cx="12458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ea typeface="宋体" panose="02010600030101010101" pitchFamily="2" charset="-122"/>
              </a:rPr>
              <a:t>Additional file </a:t>
            </a:r>
            <a:r>
              <a:rPr lang="en-US" altLang="zh-CN" sz="1200" b="1" dirty="0" smtClean="0">
                <a:latin typeface="Times New Roman" panose="02020603050405020304" pitchFamily="18" charset="0"/>
                <a:ea typeface="宋体" panose="02010600030101010101" pitchFamily="2" charset="-122"/>
              </a:rPr>
              <a:t>2</a:t>
            </a:r>
            <a:endParaRPr lang="zh-CN" altLang="en-US" sz="1200" dirty="0"/>
          </a:p>
        </p:txBody>
      </p:sp>
      <p:pic>
        <p:nvPicPr>
          <p:cNvPr id="6" name="Picture 25">
            <a:extLst>
              <a:ext uri="{FF2B5EF4-FFF2-40B4-BE49-F238E27FC236}">
                <a16:creationId xmlns:a16="http://schemas.microsoft.com/office/drawing/2014/main" xmlns="" id="{B9F5FA51-433D-4576-A02C-7F4EF2B378D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l="551" t="89505" r="13435" b="-124"/>
          <a:stretch/>
        </p:blipFill>
        <p:spPr bwMode="auto">
          <a:xfrm>
            <a:off x="733313" y="972325"/>
            <a:ext cx="8136904" cy="5040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8" name="表格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537791"/>
              </p:ext>
            </p:extLst>
          </p:nvPr>
        </p:nvGraphicFramePr>
        <p:xfrm>
          <a:off x="1907704" y="2060848"/>
          <a:ext cx="5400600" cy="3528391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2199304">
                  <a:extLst>
                    <a:ext uri="{9D8B030D-6E8A-4147-A177-3AD203B41FA5}">
                      <a16:colId xmlns:a16="http://schemas.microsoft.com/office/drawing/2014/main" xmlns="" val="1346167088"/>
                    </a:ext>
                  </a:extLst>
                </a:gridCol>
                <a:gridCol w="3201296">
                  <a:extLst>
                    <a:ext uri="{9D8B030D-6E8A-4147-A177-3AD203B41FA5}">
                      <a16:colId xmlns:a16="http://schemas.microsoft.com/office/drawing/2014/main" xmlns="" val="841235180"/>
                    </a:ext>
                  </a:extLst>
                </a:gridCol>
              </a:tblGrid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ID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10010138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1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dicted protein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90060600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2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subunit 5 nad5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466985098"/>
                  </a:ext>
                </a:extLst>
              </a:tr>
              <a:tr h="19034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3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subunit 4L nad4L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86175174"/>
                  </a:ext>
                </a:extLst>
              </a:tr>
              <a:tr h="21842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4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chrome c oxidase subunit II cox2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198323449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5 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bosomal protein S5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96179989"/>
                  </a:ext>
                </a:extLst>
              </a:tr>
              <a:tr h="216129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6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chrome c oxidase subunit III cox3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24573404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7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 synthase subunit 6 atp6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50113381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8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 synthase subunit 8 atp8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38668646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09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chrome c oxidase subunit I cox1</a:t>
                      </a:r>
                      <a:endParaRPr lang="zh-CN" sz="1000" b="1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40486973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10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subunit 6 nad6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569871617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11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subunit 2 nad2</a:t>
                      </a:r>
                      <a:endParaRPr lang="zh-CN" sz="1000" b="1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65364314"/>
                  </a:ext>
                </a:extLst>
              </a:tr>
              <a:tr h="20810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12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subunit 3 nad3</a:t>
                      </a:r>
                      <a:endParaRPr lang="zh-CN" sz="1000" b="1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77224482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13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chrome b cob</a:t>
                      </a:r>
                      <a:endParaRPr lang="zh-CN" sz="1000" b="1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62405095"/>
                  </a:ext>
                </a:extLst>
              </a:tr>
              <a:tr h="202831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14</a:t>
                      </a:r>
                      <a:endParaRPr lang="zh-CN" sz="1050" kern="1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subunit 1 nad1</a:t>
                      </a:r>
                      <a:endParaRPr lang="zh-CN" sz="1000" b="1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52740973"/>
                  </a:ext>
                </a:extLst>
              </a:tr>
              <a:tr h="221118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G_21015</a:t>
                      </a:r>
                      <a:endParaRPr lang="zh-CN" sz="105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ts val="12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DH dehydrogenase subunit 4 nad4</a:t>
                      </a:r>
                      <a:endParaRPr lang="zh-CN" sz="1000" b="1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43187273"/>
                  </a:ext>
                </a:extLst>
              </a:tr>
              <a:tr h="243132">
                <a:tc>
                  <a:txBody>
                    <a:bodyPr/>
                    <a:lstStyle/>
                    <a:p>
                      <a:pPr marL="0" marR="0" indent="0" algn="just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clear Gene MGG_00892</a:t>
                      </a:r>
                      <a:endParaRPr lang="zh-CN" altLang="zh-CN" sz="1200" b="0" kern="100" dirty="0" smtClean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ts val="12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P synthase subunit 9</a:t>
                      </a:r>
                      <a:endParaRPr lang="en-US" altLang="zh-CN" sz="1200" b="0" kern="1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4311296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71119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9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FRENACIA</dc:creator>
  <cp:lastModifiedBy>AFRENACIA</cp:lastModifiedBy>
  <cp:revision>1</cp:revision>
  <dcterms:created xsi:type="dcterms:W3CDTF">2020-01-24T06:10:12Z</dcterms:created>
  <dcterms:modified xsi:type="dcterms:W3CDTF">2020-01-24T06:11:24Z</dcterms:modified>
</cp:coreProperties>
</file>